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8" d="100"/>
          <a:sy n="78" d="100"/>
        </p:scale>
        <p:origin x="850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BE8C803-4AD2-5472-1FCC-8A2195C8603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09DA7B46-7102-B758-4983-9BF9B715F64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27C45B8-986E-7E95-9B27-2EA810D5EA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E0295-B720-4F3F-A830-AEE596FA98CE}" type="datetimeFigureOut">
              <a:rPr lang="zh-CN" altLang="en-US" smtClean="0"/>
              <a:t>2025/5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E459204-EB16-1587-E2ED-655B401CF8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9F4365D-C22F-9386-8111-1BA18C358A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63CCA-989F-40FB-90D4-B26A3922CCB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047323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090CAEF-8338-17B7-735C-3D3BEB2C03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F8A8312-EAAD-E108-7862-510E4FBE78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39E592D-F88F-D8F2-BCAA-3012C2EF49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E0295-B720-4F3F-A830-AEE596FA98CE}" type="datetimeFigureOut">
              <a:rPr lang="zh-CN" altLang="en-US" smtClean="0"/>
              <a:t>2025/5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7269693-29CB-1CE0-DB01-A505FE1278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F76C820-63A3-EF2E-BB84-B89648618B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63CCA-989F-40FB-90D4-B26A3922CCB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53128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88B9D0D3-95FE-FAAF-A293-42C5B72D40E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00BD20C-E4EF-EFA7-A81D-C2440592736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A23D046-6D60-9B59-0810-A728282378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E0295-B720-4F3F-A830-AEE596FA98CE}" type="datetimeFigureOut">
              <a:rPr lang="zh-CN" altLang="en-US" smtClean="0"/>
              <a:t>2025/5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0E58AF4-63C3-AE26-65EC-6F9E1CF8D1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FB1D136-FBF2-98D4-0FB3-58B30A6572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63CCA-989F-40FB-90D4-B26A3922CCB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07273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0674425-823C-52F1-E34B-D7F49D55DF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8732FB2-9864-CD34-79A4-2F8B97EC2A9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481148B-524A-D258-D19E-789CDA69D7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E0295-B720-4F3F-A830-AEE596FA98CE}" type="datetimeFigureOut">
              <a:rPr lang="zh-CN" altLang="en-US" smtClean="0"/>
              <a:t>2025/5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4A8D87E-311B-6D20-263E-6C6796BCBB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980797B-3BB9-CDF3-5D7A-6CFAC4F701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63CCA-989F-40FB-90D4-B26A3922CCB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47024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270779C-EA32-51EA-99CD-439F44DB93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3FDE303-ED37-2C5F-F226-56947C3D94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54E85B5-827D-08DF-111E-EF352A72CC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E0295-B720-4F3F-A830-AEE596FA98CE}" type="datetimeFigureOut">
              <a:rPr lang="zh-CN" altLang="en-US" smtClean="0"/>
              <a:t>2025/5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AE66CD3-EB0A-6577-404A-7224BAD18E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8612583-9E67-414D-1024-35953AA42D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63CCA-989F-40FB-90D4-B26A3922CCB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54421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BA241D8-485F-ED23-2CE2-7BCB8425C4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9F96E88-E388-9967-8744-78EE9F781D0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4C896C0-FC24-4FE5-75B8-96938E22826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0B001CE-F632-F910-C4A0-B8A12FC30B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E0295-B720-4F3F-A830-AEE596FA98CE}" type="datetimeFigureOut">
              <a:rPr lang="zh-CN" altLang="en-US" smtClean="0"/>
              <a:t>2025/5/2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52F84AA-5CBA-469B-099E-84928661AA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35C142C-1FA7-418F-2803-1F43FC2EF3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63CCA-989F-40FB-90D4-B26A3922CCB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8802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E85351E-A85E-A895-19F4-40AF1802C0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84691CE-31EA-6DBD-CC3E-D41F4F405C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90955AE-E96F-7AF4-32E2-EC95685169A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DBDEDB42-3338-4B89-99A0-F5BCF49B1A0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C3B65560-F926-694D-F91A-B30099CDB83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FD5C1FBF-0AAB-B6C0-B0E3-3BC2838FA2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E0295-B720-4F3F-A830-AEE596FA98CE}" type="datetimeFigureOut">
              <a:rPr lang="zh-CN" altLang="en-US" smtClean="0"/>
              <a:t>2025/5/2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BF2E4BEE-D124-6760-6A2A-5C7D8745D4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645CD142-F642-7405-9716-347BC98DBB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63CCA-989F-40FB-90D4-B26A3922CCB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48877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DAB5B66-05DF-75EF-996D-18FEA8062C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9E5359D1-455C-A351-39CA-AB92B6F00E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E0295-B720-4F3F-A830-AEE596FA98CE}" type="datetimeFigureOut">
              <a:rPr lang="zh-CN" altLang="en-US" smtClean="0"/>
              <a:t>2025/5/2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C6F48D1E-C81B-E87B-43DC-ADF2AA65C8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7C0AF228-64C9-04C2-B363-AF64374300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63CCA-989F-40FB-90D4-B26A3922CCB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19315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E1832CF1-633B-682C-F692-D28B93A718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E0295-B720-4F3F-A830-AEE596FA98CE}" type="datetimeFigureOut">
              <a:rPr lang="zh-CN" altLang="en-US" smtClean="0"/>
              <a:t>2025/5/2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19BDC15D-0537-E7F3-EA50-F62CD0C54B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BB7FCF35-E080-8D5A-CAA5-917F82077F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63CCA-989F-40FB-90D4-B26A3922CCB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59178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ADFD421-4D43-D32D-F124-1481D47F11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9C4A42B-8C50-27A5-E344-B085FEC6959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1D7E77B-1F5B-ADFF-0F13-41C7C07877B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21104E7-CF38-7CC2-3106-454944F862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E0295-B720-4F3F-A830-AEE596FA98CE}" type="datetimeFigureOut">
              <a:rPr lang="zh-CN" altLang="en-US" smtClean="0"/>
              <a:t>2025/5/2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276CF77-1C5B-A164-75A8-EFFF97F9AB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C5E5162-5635-843B-54A6-254DC53B34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63CCA-989F-40FB-90D4-B26A3922CCB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650894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BBF2B1F-7389-49DB-6D62-673563D893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82D8F50F-3101-379D-558B-549AD925344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F865ED0-0B53-0728-A649-99BFE99AB53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7CDD400-8173-D050-7A7B-527625207C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E0295-B720-4F3F-A830-AEE596FA98CE}" type="datetimeFigureOut">
              <a:rPr lang="zh-CN" altLang="en-US" smtClean="0"/>
              <a:t>2025/5/2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B932438-0737-A6BA-66C6-C8E542F8D4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D6D00F6-8151-A949-07CB-21BF4DC1F0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63CCA-989F-40FB-90D4-B26A3922CCB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99380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82B25D2B-B6B4-A69B-B035-BE1E76A09A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18FC5D5-9E14-5875-68E8-BE53A94107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30F5757-328A-6FF3-8FDA-540030788C2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EE0295-B720-4F3F-A830-AEE596FA98CE}" type="datetimeFigureOut">
              <a:rPr lang="zh-CN" altLang="en-US" smtClean="0"/>
              <a:t>2025/5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BB884A3-E899-B1EC-649F-59E01654042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94043FF-768F-7650-BAF4-73DB6829142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363CCA-989F-40FB-90D4-B26A3922CCB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01010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432B5D94-D5C6-DB36-F11B-4DD8FD9BC92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09632" y="896089"/>
            <a:ext cx="9772735" cy="2804403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9BCB0C62-DF52-9A61-A9F3-A9978950240B}"/>
              </a:ext>
            </a:extLst>
          </p:cNvPr>
          <p:cNvSpPr txBox="1"/>
          <p:nvPr/>
        </p:nvSpPr>
        <p:spPr>
          <a:xfrm>
            <a:off x="1366685" y="3906786"/>
            <a:ext cx="10015384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 1 Detection of </a:t>
            </a:r>
            <a:r>
              <a:rPr lang="en-US" altLang="zh-CN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R. </a:t>
            </a:r>
            <a:r>
              <a:rPr lang="en-US" altLang="zh-CN" sz="14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heilongjiangensis</a:t>
            </a:r>
            <a:r>
              <a:rPr lang="en-US" altLang="zh-CN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n the sera, skin (bite site), spleens, livers, lungs, and kidneys of mice on days 1, 6, and 12 post-attachment with infected nymphs, using semi-nested PCR targeting the 17-kDa gene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. 1 to 8 on Days 1 and 6 represent heart, liver, spleen, lung, kidney, brain, skin, and serum, respectively; 1 to 8 on Day 12 represent heart, serum, skin, liver, spleen, lung, kidney, and brain, respectively; P, positive control; M, DNA marker.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144433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</TotalTime>
  <Words>112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lark Q</dc:creator>
  <cp:lastModifiedBy>slark Q</cp:lastModifiedBy>
  <cp:revision>3</cp:revision>
  <dcterms:created xsi:type="dcterms:W3CDTF">2025-05-21T11:59:03Z</dcterms:created>
  <dcterms:modified xsi:type="dcterms:W3CDTF">2025-05-21T12:38:08Z</dcterms:modified>
</cp:coreProperties>
</file>